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41" d="100"/>
          <a:sy n="41" d="100"/>
        </p:scale>
        <p:origin x="-1694" y="-8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0"/>
          <p:cNvGrpSpPr/>
          <p:nvPr/>
        </p:nvGrpSpPr>
        <p:grpSpPr>
          <a:xfrm>
            <a:off x="1143000" y="4343400"/>
            <a:ext cx="2890423" cy="1476464"/>
            <a:chOff x="762000" y="3429000"/>
            <a:chExt cx="2890423" cy="1476464"/>
          </a:xfrm>
        </p:grpSpPr>
        <p:pic>
          <p:nvPicPr>
            <p:cNvPr id="5" name="Picture 2" descr="F:\dfrtgdthfyug.JPG"/>
            <p:cNvPicPr>
              <a:picLocks noChangeAspect="1" noChangeArrowheads="1"/>
            </p:cNvPicPr>
            <p:nvPr/>
          </p:nvPicPr>
          <p:blipFill>
            <a:blip r:embed="rId2" cstate="print">
              <a:grayscl/>
              <a:lum bright="12000" contrast="86000"/>
            </a:blip>
            <a:srcRect l="42202" t="16173" r="49650" b="81811"/>
            <a:stretch>
              <a:fillRect/>
            </a:stretch>
          </p:blipFill>
          <p:spPr bwMode="auto">
            <a:xfrm>
              <a:off x="1604641" y="3736032"/>
              <a:ext cx="1219200" cy="381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>
            <a:blip r:embed="rId3" cstate="print">
              <a:grayscl/>
              <a:lum bright="27000" contrast="43000"/>
            </a:blip>
            <a:srcRect/>
            <a:stretch>
              <a:fillRect/>
            </a:stretch>
          </p:blipFill>
          <p:spPr bwMode="auto">
            <a:xfrm>
              <a:off x="1604641" y="4174182"/>
              <a:ext cx="1219200" cy="35242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7" name="TextBox 6"/>
            <p:cNvSpPr txBox="1"/>
            <p:nvPr/>
          </p:nvSpPr>
          <p:spPr>
            <a:xfrm>
              <a:off x="1757040" y="4536132"/>
              <a:ext cx="4527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1.00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366641" y="4536132"/>
              <a:ext cx="3866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0.63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743200" y="4536132"/>
              <a:ext cx="9092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IkB</a:t>
              </a:r>
              <a:r>
                <a:rPr lang="el-GR" sz="900" b="1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 / </a:t>
              </a:r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tubulin</a:t>
              </a:r>
              <a:endParaRPr lang="en-US" sz="900" b="1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62000" y="3429000"/>
              <a:ext cx="9861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TPA (100ng, 2h)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757041" y="3429000"/>
              <a:ext cx="95250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   -                    +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H="1">
              <a:off x="2819400" y="3964632"/>
              <a:ext cx="182880" cy="1588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2971800" y="3859857"/>
              <a:ext cx="457200" cy="2286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IkB</a:t>
              </a:r>
              <a:r>
                <a:rPr lang="el-GR" sz="900" b="1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743200" y="4234978"/>
              <a:ext cx="6858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α-</a:t>
              </a:r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tubulin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3" name="Group 88"/>
          <p:cNvGrpSpPr/>
          <p:nvPr/>
        </p:nvGrpSpPr>
        <p:grpSpPr>
          <a:xfrm>
            <a:off x="838200" y="1521768"/>
            <a:ext cx="3542561" cy="1905000"/>
            <a:chOff x="2743200" y="761999"/>
            <a:chExt cx="3542561" cy="1905000"/>
          </a:xfrm>
        </p:grpSpPr>
        <p:pic>
          <p:nvPicPr>
            <p:cNvPr id="18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505200" y="2228849"/>
              <a:ext cx="1905000" cy="438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9" name="Picture 3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505200" y="1752599"/>
              <a:ext cx="1905000" cy="4571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" name="Picture 4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505200" y="1295399"/>
              <a:ext cx="1905000" cy="4476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1" name="TextBox 20"/>
            <p:cNvSpPr txBox="1"/>
            <p:nvPr/>
          </p:nvSpPr>
          <p:spPr>
            <a:xfrm>
              <a:off x="2743200" y="761999"/>
              <a:ext cx="1524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pcDNA3-HA      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743200" y="995775"/>
              <a:ext cx="1524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BTG2-HA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599156" y="761999"/>
              <a:ext cx="18110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    -                +                     -         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581400" y="995775"/>
              <a:ext cx="1828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     -                 -                    +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410200" y="1371599"/>
              <a:ext cx="87556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pFOXO3A</a:t>
              </a:r>
              <a:r>
                <a:rPr lang="en-US" sz="900" baseline="30000" dirty="0" smtClean="0">
                  <a:latin typeface="Times New Roman" pitchFamily="18" charset="0"/>
                  <a:cs typeface="Times New Roman" pitchFamily="18" charset="0"/>
                </a:rPr>
                <a:t>S253 </a:t>
              </a:r>
              <a:endParaRPr lang="en-US" sz="900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Rectangle 50"/>
            <p:cNvSpPr/>
            <p:nvPr/>
          </p:nvSpPr>
          <p:spPr>
            <a:xfrm>
              <a:off x="5417609" y="1902767"/>
              <a:ext cx="67839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TG2-HA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Rectangle 51"/>
            <p:cNvSpPr/>
            <p:nvPr/>
          </p:nvSpPr>
          <p:spPr>
            <a:xfrm>
              <a:off x="5410200" y="2359967"/>
              <a:ext cx="64953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sz="9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-</a:t>
              </a:r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Tubulin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152400" y="228600"/>
            <a:ext cx="2895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: Figure S1</a:t>
            </a:r>
            <a:endParaRPr lang="en-US" sz="28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33400" y="762000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1A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33400" y="3733800"/>
            <a:ext cx="609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1B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reethi</dc:creator>
  <cp:lastModifiedBy>preet</cp:lastModifiedBy>
  <cp:revision>1</cp:revision>
  <dcterms:created xsi:type="dcterms:W3CDTF">2006-08-16T00:00:00Z</dcterms:created>
  <dcterms:modified xsi:type="dcterms:W3CDTF">2013-08-24T15:06:12Z</dcterms:modified>
</cp:coreProperties>
</file>